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7"/>
  </p:notesMasterIdLst>
  <p:sldIdLst>
    <p:sldId id="423" r:id="rId3"/>
    <p:sldId id="273" r:id="rId4"/>
    <p:sldId id="418" r:id="rId5"/>
    <p:sldId id="271" r:id="rId6"/>
  </p:sldIdLst>
  <p:sldSz cx="6858000" cy="9144000" type="screen4x3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99"/>
    <a:srgbClr val="C0C0C0"/>
    <a:srgbClr val="CC0000"/>
    <a:srgbClr val="00CC00"/>
    <a:srgbClr val="FFFF66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55" autoAdjust="0"/>
    <p:restoredTop sz="95872"/>
  </p:normalViewPr>
  <p:slideViewPr>
    <p:cSldViewPr>
      <p:cViewPr>
        <p:scale>
          <a:sx n="166" d="100"/>
          <a:sy n="166" d="100"/>
        </p:scale>
        <p:origin x="1216" y="-202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tableStyles" Target="tableStyles.xml"/><Relationship Id="rId5" Type="http://schemas.openxmlformats.org/officeDocument/2006/relationships/slide" Target="slides/slide3.xml"/><Relationship Id="rId10" Type="http://schemas.openxmlformats.org/officeDocument/2006/relationships/theme" Target="theme/theme1.xml"/><Relationship Id="rId4" Type="http://schemas.openxmlformats.org/officeDocument/2006/relationships/slide" Target="slides/slide2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E92975-2E9F-49E6-9591-56DEFC9BE6BF}" type="datetimeFigureOut">
              <a:rPr lang="es-ES" smtClean="0"/>
              <a:t>12/5/22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9B28BC-A846-47DE-B691-6806EDBD727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529995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3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Google Shape;339;p20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40" name="Google Shape;340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9" name="Google Shape;349;g1223ebdf6a9_0_3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</a:pPr>
            <a:endParaRPr/>
          </a:p>
        </p:txBody>
      </p:sp>
      <p:sp>
        <p:nvSpPr>
          <p:cNvPr id="350" name="Google Shape;350;g1223ebdf6a9_0_3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AB1D3426-2EBE-AC40-B8AC-F1C3649174C9}" type="slidenum">
              <a:rPr kumimoji="0" 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0" 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0909813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OOD ON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C1A00B7-74EC-DE4A-A034-26E4EE06D17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49318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342763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74483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4260088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DDCA24-31D4-CA44-82D3-F781F47C87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A951D4E-4614-894E-9737-88DA449537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842F47-B8DA-A44B-9465-4AD042A73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0589FE-8511-5445-AFC1-4E9CF4249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DE5D38-1D51-0F4D-9F76-589AA83711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68422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D9A57B-6E53-FA49-AC4A-D3DAA4042E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B5622-3D23-4A48-B56B-38D4D876BF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21B64C-FF25-1A41-A9AB-C67E63A6FF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E98439-B04C-CF47-A560-E643034747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CC99CC-9E18-BF48-9D8D-500491CB79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3223120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B5BEA-368E-4E43-9570-EC616219B9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FC9C4C-DB00-F747-8D1D-91C36290FE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C012BA-CD4D-2349-8557-98449A90B9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E61AF6A-7A7D-3045-9856-46C5CDE2F1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F9A961-08C7-E34F-BA12-C9C4B0476D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506344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6962F-4E2D-F744-AC88-44123EC86E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D2815B-3D1A-D349-AB17-36B48D76D5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1FD952-8D0E-FC44-BCBC-EB2FF10369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59380EB-BBD6-464B-B459-10A394E68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73726DD-700B-BA44-9A65-1F9E652166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7883D3-E119-6B46-A733-C568C30F7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9256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A3F261-257C-9B4B-BB80-5B86A580C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1F85F9-8EE3-E14E-A295-F051BC7458B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AAD75C-D9E8-5C4B-B19C-70549CB6A12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7B7299-3D28-CB42-93AD-49E8340EA83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3DCBFEA-0860-FA47-BF6F-B79246CF087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7483C41-4F3E-0B4D-A284-EC3A901806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109977C-7C8E-254C-A4E2-6FCEC83B80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19C8280-5DCF-2D40-A73A-1A31F3D510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353739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158470-2E91-8047-B836-786744208C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8FCCC90-CB5A-1F4E-8A67-42D1206EDC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00C8AA-EF84-EF48-A8BD-0D55293AA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C95928-9015-D744-A4D1-2B35E0346D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767904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9B0A465-F0A7-2543-9462-FD0D0EF6C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5046384-ED53-F441-AA92-A97EB2978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5B4ABF7-DD67-9D4B-9DBE-09CF4A466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9591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D7264-1E3F-AE4F-9F23-90D0777BC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06C2F9-2B3D-4A4D-8A14-3D0737A6BA9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96917C6-DE39-1244-A9B6-21EC51306DA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0E16E9-D22B-6F4B-B7BC-15BEEAA489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559F2C-9A3F-A841-91D5-0D6DBC6DE9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D6CF31-FECF-6B4D-BD8F-F42E63B0D2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2548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4182075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A87CE1-CC39-9D40-9D14-DC3B9F7BBF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A1BBFE-31E0-E546-BD48-175FE54B01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248B5F5-C76B-5546-A510-1A00D9A64BD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D229FD-AC84-5546-9D59-B5876B323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930E1B-9C51-4C4D-9534-5AB354C3C8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574B506-BA67-564D-97E0-68EA700805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0315644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31F62A-48EF-0542-9A5A-BDDA0D7527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85475D-3ACC-9B40-8893-5393F77AE9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6B62F6-07EB-C843-8B5B-DC18FF99D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159DF2-40C6-8D40-9375-3D19EE09CF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047E22-0629-C747-A429-A7146A2D6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140836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0D7D5AC-5611-0048-A159-FF62B61D928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DCA16C0-899D-014A-A365-FAA0324C6C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F4337BA-9784-C747-9650-DD65EB7A72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EA63458-2DD5-554B-8FA5-91B9BEF69D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B08285-8000-DA4B-AC31-68D2BA3F04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737589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5526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2186961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54587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5012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929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83127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5104869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F793CD-EB54-4C2A-9F73-DAD0D089AB34}" type="datetimeFigureOut">
              <a:rPr lang="es-ES" smtClean="0"/>
              <a:t>12/5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6DA650-33F0-431C-A0CD-2F944234AF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19866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9B3AEE-3181-CB48-9641-481A4148E8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0416FAC-D3D6-834D-864B-325005C350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370BA7-2B75-384F-8E52-553CF65AE5B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16D477-F892-8A49-87A2-86E8A5E0D0AD}" type="datetimeFigureOut">
              <a:rPr lang="en-US" smtClean="0"/>
              <a:t>5/12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9BDE714-ABD1-E944-85AE-B5747FB58A2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C4DD103-B44A-5141-B360-906395F751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F4789-6B67-4844-9AD7-12BD221999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4552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3.xml"/><Relationship Id="rId4" Type="http://schemas.openxmlformats.org/officeDocument/2006/relationships/image" Target="../media/image4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Google Shape;344;p20"/>
          <p:cNvSpPr txBox="1"/>
          <p:nvPr/>
        </p:nvSpPr>
        <p:spPr>
          <a:xfrm>
            <a:off x="0" y="8035800"/>
            <a:ext cx="6858000" cy="1108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1. ACE2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olymorphisms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exhibit similar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ashion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hen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ressed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A549 cells. 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549 cells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ansfect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ither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FP-ACE2 WT, GFP-ACE2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olymorphism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r GFP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on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n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ACE2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otein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pression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alyz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 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stern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lo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MA5-32307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bod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mmunocytochemistr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ither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MA5-32307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bod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lef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anel) or MAB933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bod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igh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anel)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Nuclei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ain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DAPI (blue)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ransfect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ells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ntain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FP (green). CT: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condar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tibod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control to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detec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nspecific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inding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mage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cquir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7"/>
                  </a:ext>
                </a:extLst>
              </a:rPr>
              <a:t>Cell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extLst>
                  <a:ext uri="http://customooxmlschemas.google.com/">
              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textRoundtripDataId="7"/>
                  </a:ext>
                </a:extLst>
              </a:rPr>
              <a:t>Observer-Zeis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cal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bar: 50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highlight>
                  <a:srgbClr val="FFFFFF"/>
                </a:highlight>
                <a:latin typeface="Calibri"/>
                <a:ea typeface="Calibri"/>
                <a:cs typeface="Calibri"/>
                <a:sym typeface="Calibri"/>
              </a:rPr>
              <a:t>μm</a:t>
            </a:r>
            <a:endParaRPr sz="1100" b="1" i="1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D183C4D9-187A-594C-8052-0323A452C01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0648" y="179512"/>
            <a:ext cx="6088888" cy="7691834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3" name="Google Shape;353;g1223ebdf6a9_0_32"/>
          <p:cNvSpPr txBox="1"/>
          <p:nvPr/>
        </p:nvSpPr>
        <p:spPr>
          <a:xfrm>
            <a:off x="95250" y="7419350"/>
            <a:ext cx="6531000" cy="1446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None/>
            </a:pP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2. ACE2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issense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NPs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1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genotyping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DNA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btain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T-PCR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rom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irculating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mRNA of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tient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n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, PCR1, PCR2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CR3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erform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in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rder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o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mplif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regions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mprising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tudi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NP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PCR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oduct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er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quenc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ign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gains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ferenc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CE2 (NM_021804). PCR1: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idue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rom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Ser3 to Met249 (743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p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, PCR2: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idue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he308 to Arg621 (944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p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, PCR3: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sidue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rom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Val670 to Val752 (250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p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 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)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garos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gel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lectrophoresi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ith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CR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oduct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veral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tient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wa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erform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o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nfirm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pecificity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r>
              <a:rPr lang="ca-ES" sz="11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)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presentativ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mag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lignmen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of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equence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(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orwar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nd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vers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) PCR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roduct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gains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eferenc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ACE2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using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napGen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® Software. In particular,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imag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orresponds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to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CR2 of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non-ICU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atien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10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at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presents </a:t>
            </a:r>
            <a:r>
              <a:rPr lang="ca-ES" sz="1100" b="0" i="0" u="none" strike="noStrike" cap="none" dirty="0" err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the</a:t>
            </a:r>
            <a:r>
              <a:rPr lang="ca-ES" sz="11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 L351V variant</a:t>
            </a:r>
            <a:endParaRPr sz="11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C853DE6-522D-3442-AC30-E5E5E58BE34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0050" y="334900"/>
            <a:ext cx="6121400" cy="67310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1B13157-62D7-454C-90AD-5CC21389AA2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0233" y="2772694"/>
            <a:ext cx="6397534" cy="359861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C382CCD4-CA57-ED49-8F07-7E9E7A21154D}"/>
              </a:ext>
            </a:extLst>
          </p:cNvPr>
          <p:cNvSpPr txBox="1"/>
          <p:nvPr/>
        </p:nvSpPr>
        <p:spPr>
          <a:xfrm>
            <a:off x="230232" y="6267432"/>
            <a:ext cx="6397534" cy="4040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50"/>
            <a:r>
              <a:rPr lang="en-US" sz="1013" b="1" dirty="0">
                <a:solidFill>
                  <a:prstClr val="black"/>
                </a:solidFill>
                <a:latin typeface="Calibri" panose="020F0502020204030204"/>
              </a:rPr>
              <a:t>Supplemental Figure 3</a:t>
            </a:r>
            <a:r>
              <a:rPr lang="en-US" sz="1013" dirty="0">
                <a:solidFill>
                  <a:prstClr val="black"/>
                </a:solidFill>
                <a:latin typeface="Calibri" panose="020F0502020204030204"/>
              </a:rPr>
              <a:t>. Frequency distribution of ACE2 genotypes by sex. A) ‘promoting’ alleles; B) ‘Protective’ alleles: C) ‘WT’ alleles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B2EE5C38-9F6E-2E4F-AF51-C844FF7838D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27716" y="2883769"/>
            <a:ext cx="400050" cy="2643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353154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E6C9C0E1-D752-6046-9998-AEA0BDE8F7B4}"/>
              </a:ext>
            </a:extLst>
          </p:cNvPr>
          <p:cNvSpPr txBox="1"/>
          <p:nvPr/>
        </p:nvSpPr>
        <p:spPr>
          <a:xfrm>
            <a:off x="199460" y="8615158"/>
            <a:ext cx="6397534" cy="2482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514350"/>
            <a:r>
              <a:rPr lang="en-US" sz="1013" b="1" dirty="0">
                <a:solidFill>
                  <a:prstClr val="black"/>
                </a:solidFill>
              </a:rPr>
              <a:t>Supplemental Figure 4. GDF15 and ACE2 levels across ACE2 variants. A) GDF15 levels; B) ACE2 levels; C) ACE2 mRNA</a:t>
            </a:r>
            <a:endParaRPr lang="en-US" sz="1013" dirty="0">
              <a:solidFill>
                <a:prstClr val="black"/>
              </a:solidFill>
              <a:latin typeface="Calibri" panose="020F0502020204030204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2899ACDD-AAC7-4A4C-B5DC-12568441532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534" y="624461"/>
            <a:ext cx="4093963" cy="2286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19AAF750-678D-9E43-AEDE-91D6224BAE74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88" y="6023088"/>
            <a:ext cx="4093963" cy="22860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95F0234D-E370-0249-9129-0EB4E4A3B80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0688" y="3291776"/>
            <a:ext cx="4093963" cy="22860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9DE84396-7D91-DA48-AAD4-A6BD17BEDB29}"/>
              </a:ext>
            </a:extLst>
          </p:cNvPr>
          <p:cNvSpPr txBox="1"/>
          <p:nvPr/>
        </p:nvSpPr>
        <p:spPr>
          <a:xfrm>
            <a:off x="260648" y="467544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A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7C08FA69-BF88-CB43-9562-37871AF41442}"/>
              </a:ext>
            </a:extLst>
          </p:cNvPr>
          <p:cNvSpPr txBox="1"/>
          <p:nvPr/>
        </p:nvSpPr>
        <p:spPr>
          <a:xfrm>
            <a:off x="343544" y="3032240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8D1B7DF-3CFB-2343-9F1F-EC75B0F4C788}"/>
              </a:ext>
            </a:extLst>
          </p:cNvPr>
          <p:cNvSpPr txBox="1"/>
          <p:nvPr/>
        </p:nvSpPr>
        <p:spPr>
          <a:xfrm>
            <a:off x="368660" y="5661932"/>
            <a:ext cx="5040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C)</a:t>
            </a:r>
          </a:p>
        </p:txBody>
      </p:sp>
    </p:spTree>
    <p:extLst>
      <p:ext uri="{BB962C8B-B14F-4D97-AF65-F5344CB8AC3E}">
        <p14:creationId xmlns:p14="http://schemas.microsoft.com/office/powerpoint/2010/main" val="224279910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606</TotalTime>
  <Words>321</Words>
  <Application>Microsoft Macintosh PowerPoint</Application>
  <PresentationFormat>On-screen Show (4:3)</PresentationFormat>
  <Paragraphs>1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arlos Barcelo Pascual</dc:creator>
  <cp:lastModifiedBy>Marta Gonzalez Freire</cp:lastModifiedBy>
  <cp:revision>110</cp:revision>
  <dcterms:created xsi:type="dcterms:W3CDTF">2021-08-17T12:31:08Z</dcterms:created>
  <dcterms:modified xsi:type="dcterms:W3CDTF">2022-05-12T11:21:00Z</dcterms:modified>
</cp:coreProperties>
</file>